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9" r:id="rId2"/>
    <p:sldId id="261" r:id="rId3"/>
  </p:sldIdLst>
  <p:sldSz cx="7199313" cy="45005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BD09B7D-6F26-4B3F-8236-65BC4786D47D}" v="3" dt="2024-02-06T13:27:34.07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7" d="100"/>
          <a:sy n="157" d="100"/>
        </p:scale>
        <p:origin x="1170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9914" y="736551"/>
            <a:ext cx="5399485" cy="1566863"/>
          </a:xfrm>
        </p:spPr>
        <p:txBody>
          <a:bodyPr anchor="b"/>
          <a:lstStyle>
            <a:lvl1pPr algn="ctr">
              <a:defRPr sz="3543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2363838"/>
            <a:ext cx="5399485" cy="1086594"/>
          </a:xfrm>
        </p:spPr>
        <p:txBody>
          <a:bodyPr/>
          <a:lstStyle>
            <a:lvl1pPr marL="0" indent="0" algn="ctr">
              <a:buNone/>
              <a:defRPr sz="1417"/>
            </a:lvl1pPr>
            <a:lvl2pPr marL="269977" indent="0" algn="ctr">
              <a:buNone/>
              <a:defRPr sz="1181"/>
            </a:lvl2pPr>
            <a:lvl3pPr marL="539953" indent="0" algn="ctr">
              <a:buNone/>
              <a:defRPr sz="1063"/>
            </a:lvl3pPr>
            <a:lvl4pPr marL="809930" indent="0" algn="ctr">
              <a:buNone/>
              <a:defRPr sz="945"/>
            </a:lvl4pPr>
            <a:lvl5pPr marL="1079906" indent="0" algn="ctr">
              <a:buNone/>
              <a:defRPr sz="945"/>
            </a:lvl5pPr>
            <a:lvl6pPr marL="1349883" indent="0" algn="ctr">
              <a:buNone/>
              <a:defRPr sz="945"/>
            </a:lvl6pPr>
            <a:lvl7pPr marL="1619860" indent="0" algn="ctr">
              <a:buNone/>
              <a:defRPr sz="945"/>
            </a:lvl7pPr>
            <a:lvl8pPr marL="1889836" indent="0" algn="ctr">
              <a:buNone/>
              <a:defRPr sz="945"/>
            </a:lvl8pPr>
            <a:lvl9pPr marL="2159813" indent="0" algn="ctr">
              <a:buNone/>
              <a:defRPr sz="945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CCDE1-F06D-454F-8EB6-66929D42C071}" type="datetimeFigureOut">
              <a:rPr lang="en-GB" smtClean="0"/>
              <a:t>12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1F19C-06B8-4973-BF7E-CE61F077E0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0074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CCDE1-F06D-454F-8EB6-66929D42C071}" type="datetimeFigureOut">
              <a:rPr lang="en-GB" smtClean="0"/>
              <a:t>12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1F19C-06B8-4973-BF7E-CE61F077E0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6293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8" y="239613"/>
            <a:ext cx="1552352" cy="3814019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239613"/>
            <a:ext cx="4567064" cy="3814019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CCDE1-F06D-454F-8EB6-66929D42C071}" type="datetimeFigureOut">
              <a:rPr lang="en-GB" smtClean="0"/>
              <a:t>12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1F19C-06B8-4973-BF7E-CE61F077E0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7757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CCDE1-F06D-454F-8EB6-66929D42C071}" type="datetimeFigureOut">
              <a:rPr lang="en-GB" smtClean="0"/>
              <a:t>12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1F19C-06B8-4973-BF7E-CE61F077E0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9437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3" y="1122016"/>
            <a:ext cx="6209407" cy="1872109"/>
          </a:xfrm>
        </p:spPr>
        <p:txBody>
          <a:bodyPr anchor="b"/>
          <a:lstStyle>
            <a:lvl1pPr>
              <a:defRPr sz="3543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3" y="3011836"/>
            <a:ext cx="6209407" cy="984498"/>
          </a:xfrm>
        </p:spPr>
        <p:txBody>
          <a:bodyPr/>
          <a:lstStyle>
            <a:lvl1pPr marL="0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1pPr>
            <a:lvl2pPr marL="269977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2pPr>
            <a:lvl3pPr marL="539953" indent="0">
              <a:buNone/>
              <a:defRPr sz="1063">
                <a:solidFill>
                  <a:schemeClr val="tx1">
                    <a:tint val="75000"/>
                  </a:schemeClr>
                </a:solidFill>
              </a:defRPr>
            </a:lvl3pPr>
            <a:lvl4pPr marL="809930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4pPr>
            <a:lvl5pPr marL="1079906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5pPr>
            <a:lvl6pPr marL="1349883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6pPr>
            <a:lvl7pPr marL="1619860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7pPr>
            <a:lvl8pPr marL="1889836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8pPr>
            <a:lvl9pPr marL="2159813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CCDE1-F06D-454F-8EB6-66929D42C071}" type="datetimeFigureOut">
              <a:rPr lang="en-GB" smtClean="0"/>
              <a:t>12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1F19C-06B8-4973-BF7E-CE61F077E0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2344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198066"/>
            <a:ext cx="3059708" cy="28555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198066"/>
            <a:ext cx="3059708" cy="28555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CCDE1-F06D-454F-8EB6-66929D42C071}" type="datetimeFigureOut">
              <a:rPr lang="en-GB" smtClean="0"/>
              <a:t>12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1F19C-06B8-4973-BF7E-CE61F077E0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4934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239614"/>
            <a:ext cx="6209407" cy="869901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103263"/>
            <a:ext cx="3045647" cy="540692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69977" indent="0">
              <a:buNone/>
              <a:defRPr sz="1181" b="1"/>
            </a:lvl2pPr>
            <a:lvl3pPr marL="539953" indent="0">
              <a:buNone/>
              <a:defRPr sz="1063" b="1"/>
            </a:lvl3pPr>
            <a:lvl4pPr marL="809930" indent="0">
              <a:buNone/>
              <a:defRPr sz="945" b="1"/>
            </a:lvl4pPr>
            <a:lvl5pPr marL="1079906" indent="0">
              <a:buNone/>
              <a:defRPr sz="945" b="1"/>
            </a:lvl5pPr>
            <a:lvl6pPr marL="1349883" indent="0">
              <a:buNone/>
              <a:defRPr sz="945" b="1"/>
            </a:lvl6pPr>
            <a:lvl7pPr marL="1619860" indent="0">
              <a:buNone/>
              <a:defRPr sz="945" b="1"/>
            </a:lvl7pPr>
            <a:lvl8pPr marL="1889836" indent="0">
              <a:buNone/>
              <a:defRPr sz="945" b="1"/>
            </a:lvl8pPr>
            <a:lvl9pPr marL="2159813" indent="0">
              <a:buNone/>
              <a:defRPr sz="945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1643956"/>
            <a:ext cx="3045647" cy="241801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103263"/>
            <a:ext cx="3060646" cy="540692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69977" indent="0">
              <a:buNone/>
              <a:defRPr sz="1181" b="1"/>
            </a:lvl2pPr>
            <a:lvl3pPr marL="539953" indent="0">
              <a:buNone/>
              <a:defRPr sz="1063" b="1"/>
            </a:lvl3pPr>
            <a:lvl4pPr marL="809930" indent="0">
              <a:buNone/>
              <a:defRPr sz="945" b="1"/>
            </a:lvl4pPr>
            <a:lvl5pPr marL="1079906" indent="0">
              <a:buNone/>
              <a:defRPr sz="945" b="1"/>
            </a:lvl5pPr>
            <a:lvl6pPr marL="1349883" indent="0">
              <a:buNone/>
              <a:defRPr sz="945" b="1"/>
            </a:lvl6pPr>
            <a:lvl7pPr marL="1619860" indent="0">
              <a:buNone/>
              <a:defRPr sz="945" b="1"/>
            </a:lvl7pPr>
            <a:lvl8pPr marL="1889836" indent="0">
              <a:buNone/>
              <a:defRPr sz="945" b="1"/>
            </a:lvl8pPr>
            <a:lvl9pPr marL="2159813" indent="0">
              <a:buNone/>
              <a:defRPr sz="945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1643956"/>
            <a:ext cx="3060646" cy="241801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CCDE1-F06D-454F-8EB6-66929D42C071}" type="datetimeFigureOut">
              <a:rPr lang="en-GB" smtClean="0"/>
              <a:t>12/04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1F19C-06B8-4973-BF7E-CE61F077E0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1299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CCDE1-F06D-454F-8EB6-66929D42C071}" type="datetimeFigureOut">
              <a:rPr lang="en-GB" smtClean="0"/>
              <a:t>12/04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1F19C-06B8-4973-BF7E-CE61F077E0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8097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CCDE1-F06D-454F-8EB6-66929D42C071}" type="datetimeFigureOut">
              <a:rPr lang="en-GB" smtClean="0"/>
              <a:t>12/04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1F19C-06B8-4973-BF7E-CE61F077E0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898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300038"/>
            <a:ext cx="2321966" cy="1050131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647998"/>
            <a:ext cx="3644652" cy="3198317"/>
          </a:xfrm>
        </p:spPr>
        <p:txBody>
          <a:bodyPr/>
          <a:lstStyle>
            <a:lvl1pPr>
              <a:defRPr sz="1890"/>
            </a:lvl1pPr>
            <a:lvl2pPr>
              <a:defRPr sz="1653"/>
            </a:lvl2pPr>
            <a:lvl3pPr>
              <a:defRPr sz="1417"/>
            </a:lvl3pPr>
            <a:lvl4pPr>
              <a:defRPr sz="1181"/>
            </a:lvl4pPr>
            <a:lvl5pPr>
              <a:defRPr sz="1181"/>
            </a:lvl5pPr>
            <a:lvl6pPr>
              <a:defRPr sz="1181"/>
            </a:lvl6pPr>
            <a:lvl7pPr>
              <a:defRPr sz="1181"/>
            </a:lvl7pPr>
            <a:lvl8pPr>
              <a:defRPr sz="1181"/>
            </a:lvl8pPr>
            <a:lvl9pPr>
              <a:defRPr sz="1181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1" y="1350169"/>
            <a:ext cx="2321966" cy="2501355"/>
          </a:xfrm>
        </p:spPr>
        <p:txBody>
          <a:bodyPr/>
          <a:lstStyle>
            <a:lvl1pPr marL="0" indent="0">
              <a:buNone/>
              <a:defRPr sz="945"/>
            </a:lvl1pPr>
            <a:lvl2pPr marL="269977" indent="0">
              <a:buNone/>
              <a:defRPr sz="827"/>
            </a:lvl2pPr>
            <a:lvl3pPr marL="539953" indent="0">
              <a:buNone/>
              <a:defRPr sz="709"/>
            </a:lvl3pPr>
            <a:lvl4pPr marL="809930" indent="0">
              <a:buNone/>
              <a:defRPr sz="591"/>
            </a:lvl4pPr>
            <a:lvl5pPr marL="1079906" indent="0">
              <a:buNone/>
              <a:defRPr sz="591"/>
            </a:lvl5pPr>
            <a:lvl6pPr marL="1349883" indent="0">
              <a:buNone/>
              <a:defRPr sz="591"/>
            </a:lvl6pPr>
            <a:lvl7pPr marL="1619860" indent="0">
              <a:buNone/>
              <a:defRPr sz="591"/>
            </a:lvl7pPr>
            <a:lvl8pPr marL="1889836" indent="0">
              <a:buNone/>
              <a:defRPr sz="591"/>
            </a:lvl8pPr>
            <a:lvl9pPr marL="2159813" indent="0">
              <a:buNone/>
              <a:defRPr sz="59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CCDE1-F06D-454F-8EB6-66929D42C071}" type="datetimeFigureOut">
              <a:rPr lang="en-GB" smtClean="0"/>
              <a:t>12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1F19C-06B8-4973-BF7E-CE61F077E0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579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300038"/>
            <a:ext cx="2321966" cy="1050131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647998"/>
            <a:ext cx="3644652" cy="3198317"/>
          </a:xfrm>
        </p:spPr>
        <p:txBody>
          <a:bodyPr anchor="t"/>
          <a:lstStyle>
            <a:lvl1pPr marL="0" indent="0">
              <a:buNone/>
              <a:defRPr sz="1890"/>
            </a:lvl1pPr>
            <a:lvl2pPr marL="269977" indent="0">
              <a:buNone/>
              <a:defRPr sz="1653"/>
            </a:lvl2pPr>
            <a:lvl3pPr marL="539953" indent="0">
              <a:buNone/>
              <a:defRPr sz="1417"/>
            </a:lvl3pPr>
            <a:lvl4pPr marL="809930" indent="0">
              <a:buNone/>
              <a:defRPr sz="1181"/>
            </a:lvl4pPr>
            <a:lvl5pPr marL="1079906" indent="0">
              <a:buNone/>
              <a:defRPr sz="1181"/>
            </a:lvl5pPr>
            <a:lvl6pPr marL="1349883" indent="0">
              <a:buNone/>
              <a:defRPr sz="1181"/>
            </a:lvl6pPr>
            <a:lvl7pPr marL="1619860" indent="0">
              <a:buNone/>
              <a:defRPr sz="1181"/>
            </a:lvl7pPr>
            <a:lvl8pPr marL="1889836" indent="0">
              <a:buNone/>
              <a:defRPr sz="1181"/>
            </a:lvl8pPr>
            <a:lvl9pPr marL="2159813" indent="0">
              <a:buNone/>
              <a:defRPr sz="1181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1" y="1350169"/>
            <a:ext cx="2321966" cy="2501355"/>
          </a:xfrm>
        </p:spPr>
        <p:txBody>
          <a:bodyPr/>
          <a:lstStyle>
            <a:lvl1pPr marL="0" indent="0">
              <a:buNone/>
              <a:defRPr sz="945"/>
            </a:lvl1pPr>
            <a:lvl2pPr marL="269977" indent="0">
              <a:buNone/>
              <a:defRPr sz="827"/>
            </a:lvl2pPr>
            <a:lvl3pPr marL="539953" indent="0">
              <a:buNone/>
              <a:defRPr sz="709"/>
            </a:lvl3pPr>
            <a:lvl4pPr marL="809930" indent="0">
              <a:buNone/>
              <a:defRPr sz="591"/>
            </a:lvl4pPr>
            <a:lvl5pPr marL="1079906" indent="0">
              <a:buNone/>
              <a:defRPr sz="591"/>
            </a:lvl5pPr>
            <a:lvl6pPr marL="1349883" indent="0">
              <a:buNone/>
              <a:defRPr sz="591"/>
            </a:lvl6pPr>
            <a:lvl7pPr marL="1619860" indent="0">
              <a:buNone/>
              <a:defRPr sz="591"/>
            </a:lvl7pPr>
            <a:lvl8pPr marL="1889836" indent="0">
              <a:buNone/>
              <a:defRPr sz="591"/>
            </a:lvl8pPr>
            <a:lvl9pPr marL="2159813" indent="0">
              <a:buNone/>
              <a:defRPr sz="59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CCDE1-F06D-454F-8EB6-66929D42C071}" type="datetimeFigureOut">
              <a:rPr lang="en-GB" smtClean="0"/>
              <a:t>12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1F19C-06B8-4973-BF7E-CE61F077E0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5959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239614"/>
            <a:ext cx="6209407" cy="869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198066"/>
            <a:ext cx="6209407" cy="28555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4171356"/>
            <a:ext cx="1619845" cy="2396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ACCDE1-F06D-454F-8EB6-66929D42C071}" type="datetimeFigureOut">
              <a:rPr lang="en-GB" smtClean="0"/>
              <a:t>12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4171356"/>
            <a:ext cx="2429768" cy="2396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4171356"/>
            <a:ext cx="1619845" cy="2396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1F19C-06B8-4973-BF7E-CE61F077E0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7168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39953" rtl="0" eaLnBrk="1" latinLnBrk="0" hangingPunct="1">
        <a:lnSpc>
          <a:spcPct val="90000"/>
        </a:lnSpc>
        <a:spcBef>
          <a:spcPct val="0"/>
        </a:spcBef>
        <a:buNone/>
        <a:defRPr sz="259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4988" indent="-134988" algn="l" defTabSz="539953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1pPr>
      <a:lvl2pPr marL="404965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674942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181" kern="1200">
          <a:solidFill>
            <a:schemeClr val="tx1"/>
          </a:solidFill>
          <a:latin typeface="+mn-lt"/>
          <a:ea typeface="+mn-ea"/>
          <a:cs typeface="+mn-cs"/>
        </a:defRPr>
      </a:lvl3pPr>
      <a:lvl4pPr marL="944918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214895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484871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754848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2024825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294801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1pPr>
      <a:lvl2pPr marL="269977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2pPr>
      <a:lvl3pPr marL="539953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3pPr>
      <a:lvl4pPr marL="809930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079906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349883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619860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1889836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159813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E8DF3A6A-46B8-006F-8CCE-DBDA5981AD58}"/>
              </a:ext>
            </a:extLst>
          </p:cNvPr>
          <p:cNvGrpSpPr/>
          <p:nvPr/>
        </p:nvGrpSpPr>
        <p:grpSpPr>
          <a:xfrm>
            <a:off x="539159" y="0"/>
            <a:ext cx="6120995" cy="4500563"/>
            <a:chOff x="539159" y="0"/>
            <a:chExt cx="6120995" cy="450056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31A1F29-3855-90B7-DE67-3BA90E61345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39159" y="0"/>
              <a:ext cx="6120995" cy="4500563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9D1C207-A1B9-D924-25A5-CC630C605E25}"/>
                </a:ext>
              </a:extLst>
            </p:cNvPr>
            <p:cNvSpPr txBox="1"/>
            <p:nvPr/>
          </p:nvSpPr>
          <p:spPr>
            <a:xfrm>
              <a:off x="5202395" y="171350"/>
              <a:ext cx="2391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0F7BF3B-8F6A-C09B-6379-92B2E6A6B6CE}"/>
                </a:ext>
              </a:extLst>
            </p:cNvPr>
            <p:cNvSpPr txBox="1"/>
            <p:nvPr/>
          </p:nvSpPr>
          <p:spPr>
            <a:xfrm>
              <a:off x="3716831" y="1622055"/>
              <a:ext cx="2936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093D90F-4A89-5EB0-F461-8CD73B2CE4C1}"/>
                </a:ext>
              </a:extLst>
            </p:cNvPr>
            <p:cNvSpPr txBox="1"/>
            <p:nvPr/>
          </p:nvSpPr>
          <p:spPr>
            <a:xfrm>
              <a:off x="6213330" y="1699820"/>
              <a:ext cx="2391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083E4FD-14AD-0B43-D388-C5FF09266D83}"/>
              </a:ext>
            </a:extLst>
          </p:cNvPr>
          <p:cNvSpPr txBox="1"/>
          <p:nvPr/>
        </p:nvSpPr>
        <p:spPr>
          <a:xfrm>
            <a:off x="3607254" y="3086646"/>
            <a:ext cx="3429450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sz="9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um concentration of CRP (mg/dl) and cytokines (</a:t>
            </a:r>
            <a:r>
              <a:rPr lang="en-US" sz="9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g</a:t>
            </a:r>
            <a:r>
              <a:rPr lang="en-US" sz="9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ml) in AP T1, T2, T3, and T4 assessments, according to cause of AP. Data are reported as mean ± SD. Differences between BISAP subgroups at each AP time point were tested using an Unpaired t-test with Welch’s correction: *p&lt;0.05; **p&lt;0.01. CRP, C-reactive protein; IL-, interleukin; INF, interferon; VEGF, vascular endothelial growth factor; TNF, tumor necrosis factor; MCP, monocyte chemotactic protein. </a:t>
            </a:r>
            <a:endParaRPr lang="en-GB" sz="9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00755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5C9DF1F-9E39-4363-24E9-1AA4F84090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717853" cy="425756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586D780-63A8-EF21-FD83-00234FBE313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124" t="13928" r="80851" b="71413"/>
          <a:stretch/>
        </p:blipFill>
        <p:spPr>
          <a:xfrm>
            <a:off x="3430637" y="3126846"/>
            <a:ext cx="865725" cy="62408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314A152-0BF0-1BAC-50D7-8CF56B38F071}"/>
              </a:ext>
            </a:extLst>
          </p:cNvPr>
          <p:cNvSpPr txBox="1"/>
          <p:nvPr/>
        </p:nvSpPr>
        <p:spPr>
          <a:xfrm>
            <a:off x="955711" y="205600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6D02732-D6CD-1725-81D1-A2162A03F4E0}"/>
              </a:ext>
            </a:extLst>
          </p:cNvPr>
          <p:cNvSpPr txBox="1"/>
          <p:nvPr/>
        </p:nvSpPr>
        <p:spPr>
          <a:xfrm>
            <a:off x="4344960" y="2812405"/>
            <a:ext cx="2854353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GB" sz="900" b="1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um concentration of CRP (mg/dl) and cytokines (</a:t>
            </a:r>
            <a:r>
              <a:rPr lang="en-US" sz="9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g</a:t>
            </a:r>
            <a:r>
              <a:rPr lang="en-US" sz="9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ml) in AP T1, T2, T3, and T4 assessments, according to BMI classification. Data are reported as mean ± SD. Differences between BISAP subgroups at each AP time point were tested using an Unpaired t-test with Welch’s correction: *p&lt;0.05. CRP, C-reactive protein; IL-, interleukin; INF, interferon; VEGF, vascular endothelial growth factor; TNF, tumor necrosis factor; MCP, monocyte chemotactic protein.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86803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826</TotalTime>
  <Words>212</Words>
  <Application>Microsoft Office PowerPoint</Application>
  <PresentationFormat>Custom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guel Dias</dc:creator>
  <cp:lastModifiedBy>MDPI</cp:lastModifiedBy>
  <cp:revision>7</cp:revision>
  <dcterms:created xsi:type="dcterms:W3CDTF">2024-01-26T15:03:20Z</dcterms:created>
  <dcterms:modified xsi:type="dcterms:W3CDTF">2024-04-12T06:38:48Z</dcterms:modified>
</cp:coreProperties>
</file>